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5393" autoAdjust="0"/>
    <p:restoredTop sz="94660"/>
  </p:normalViewPr>
  <p:slideViewPr>
    <p:cSldViewPr>
      <p:cViewPr varScale="1">
        <p:scale>
          <a:sx n="122" d="100"/>
          <a:sy n="122" d="100"/>
        </p:scale>
        <p:origin x="84" y="74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5/12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2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2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2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2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2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12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5/1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95536" y="5288001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Rothberg et al (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2023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Diabetologia DOI 10.1007/s00125-0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23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06069-1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A schematic view of the progression of prediabetes to type 2 diabetes</a:t>
            </a:r>
            <a:endParaRPr lang="en-GB" sz="18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DC5BBC3-DF6D-EEC9-209E-E3A76E55074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29885" y="1078674"/>
            <a:ext cx="4724190" cy="41498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7</cp:revision>
  <dcterms:created xsi:type="dcterms:W3CDTF">2016-06-15T12:53:43Z</dcterms:created>
  <dcterms:modified xsi:type="dcterms:W3CDTF">2023-12-15T10:47:39Z</dcterms:modified>
</cp:coreProperties>
</file>